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56" r:id="rId2"/>
    <p:sldId id="258" r:id="rId3"/>
    <p:sldId id="259" r:id="rId4"/>
    <p:sldId id="260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248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9DAB36-20B1-42FE-81FF-DA3D4EFF8FAA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79C92E-F674-422B-A970-049E9A22D5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0145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1D502-A172-4A47-97AF-B919498612EE}" type="datetime1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724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B469-DB71-4896-AFFB-39E2469373D5}" type="datetime1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512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5B12F-FA51-47EA-9CF0-BF6B8E1C753F}" type="datetime1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951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78E83F-74A0-42C3-9176-6E819D01AE16}" type="datetime1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203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FC57F-B186-4092-B0CE-B0692093729E}" type="datetime1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577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B066F-EF83-4D54-940C-5FA3F718884B}" type="datetime1">
              <a:rPr lang="en-US" smtClean="0"/>
              <a:t>9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931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646A6-82F2-45B4-9004-1596C4A43710}" type="datetime1">
              <a:rPr lang="en-US" smtClean="0"/>
              <a:t>9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241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E134A-DE9F-403F-ABE0-563E0DAFB84A}" type="datetime1">
              <a:rPr lang="en-US" smtClean="0"/>
              <a:t>9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68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D4E45-C5AF-48FA-A8E1-B594C236332E}" type="datetime1">
              <a:rPr lang="en-US" smtClean="0"/>
              <a:t>9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47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A993D-563F-422F-B7CA-7940CBEA8C65}" type="datetime1">
              <a:rPr lang="en-US" smtClean="0"/>
              <a:t>9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484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AE8D6-9690-47B4-87BA-2755ACC43CF0}" type="datetime1">
              <a:rPr lang="en-US" smtClean="0"/>
              <a:t>9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561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445F8-3B5E-4A25-B2CD-C4F9247DBE1D}" type="datetime1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70F41D-5E2E-496D-BFB7-3CEBB8FBC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537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E9617C4E-F6D3-4DCE-8CAB-4B99D84694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1160" y="6425207"/>
            <a:ext cx="3020635" cy="271576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8338394-CDB9-4232-AC32-28ADB258D27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36" y="6429017"/>
            <a:ext cx="3020635" cy="271576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F12C3DE-F5B9-43B7-893F-0C3D830B37B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9234" y="3592166"/>
            <a:ext cx="3020635" cy="271576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6877C1D-FC2B-4F2E-A2BA-8A88A2CC7BF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36" y="3592166"/>
            <a:ext cx="3020635" cy="271576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8E77F0C-3D78-44BF-8B01-A1CF4172D91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350" y="756870"/>
            <a:ext cx="3020635" cy="2715768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337339AC-BC12-4F04-B183-F10D481FA18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724" y="758906"/>
            <a:ext cx="3020635" cy="271576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03A6B4B-65ED-4618-A1D7-D5481A93FBAD}"/>
              </a:ext>
            </a:extLst>
          </p:cNvPr>
          <p:cNvSpPr txBox="1"/>
          <p:nvPr/>
        </p:nvSpPr>
        <p:spPr>
          <a:xfrm>
            <a:off x="0" y="8855528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</a:t>
            </a:r>
          </a:p>
          <a:p>
            <a:r>
              <a:rPr lang="en-US" sz="600" dirty="0"/>
              <a:t>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endParaRPr lang="en-US" sz="6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93C29DA-87D1-47D7-9004-5A66292E2386}"/>
              </a:ext>
            </a:extLst>
          </p:cNvPr>
          <p:cNvSpPr txBox="1"/>
          <p:nvPr/>
        </p:nvSpPr>
        <p:spPr>
          <a:xfrm>
            <a:off x="2" y="6022296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</a:t>
            </a:r>
          </a:p>
          <a:p>
            <a:r>
              <a:rPr lang="en-US" sz="600" dirty="0"/>
              <a:t>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endParaRPr lang="en-US" sz="6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C7372F3-C6FB-40AF-BB64-BAE393B4F855}"/>
              </a:ext>
            </a:extLst>
          </p:cNvPr>
          <p:cNvSpPr txBox="1"/>
          <p:nvPr/>
        </p:nvSpPr>
        <p:spPr>
          <a:xfrm>
            <a:off x="-1" y="3199448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                         </a:t>
            </a:r>
          </a:p>
          <a:p>
            <a:r>
              <a:rPr lang="en-US" sz="600" dirty="0"/>
              <a:t>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543731C-A43A-49A4-9E34-99D5B7D80391}"/>
              </a:ext>
            </a:extLst>
          </p:cNvPr>
          <p:cNvSpPr txBox="1"/>
          <p:nvPr/>
        </p:nvSpPr>
        <p:spPr>
          <a:xfrm>
            <a:off x="188321" y="105846"/>
            <a:ext cx="606484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dditional file 5. VITdAL-ICU cohort Day 0 Short Chain Acylcarnitines by N-formylmethionine quartiles</a:t>
            </a:r>
            <a:r>
              <a:rPr lang="en-US" sz="1200" b="1" dirty="0"/>
              <a:t>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9EDE0B1-48DB-4F47-92C7-4E1944AD044D}"/>
              </a:ext>
            </a:extLst>
          </p:cNvPr>
          <p:cNvSpPr txBox="1"/>
          <p:nvPr/>
        </p:nvSpPr>
        <p:spPr>
          <a:xfrm>
            <a:off x="311700" y="811460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/>
              <a:t>succinylcarnitine</a:t>
            </a:r>
            <a:r>
              <a:rPr lang="en-US" sz="800" dirty="0"/>
              <a:t> (C4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6E9EAEE-30AB-40D3-883B-E810817F0FD2}"/>
              </a:ext>
            </a:extLst>
          </p:cNvPr>
          <p:cNvSpPr txBox="1"/>
          <p:nvPr/>
        </p:nvSpPr>
        <p:spPr>
          <a:xfrm>
            <a:off x="3826433" y="811460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2-methylbutyroylcarnitine (C5)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B5E89BB-146B-4DBB-8599-80E7EA0EEF09}"/>
              </a:ext>
            </a:extLst>
          </p:cNvPr>
          <p:cNvSpPr/>
          <p:nvPr/>
        </p:nvSpPr>
        <p:spPr>
          <a:xfrm>
            <a:off x="0" y="962025"/>
            <a:ext cx="188321" cy="7939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120134E-3B46-4FA6-87CA-9F28BF933C17}"/>
              </a:ext>
            </a:extLst>
          </p:cNvPr>
          <p:cNvSpPr/>
          <p:nvPr/>
        </p:nvSpPr>
        <p:spPr>
          <a:xfrm>
            <a:off x="3552833" y="1052506"/>
            <a:ext cx="188321" cy="7939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058FDA6-AAFF-4D90-85EC-B7A4D310247D}"/>
              </a:ext>
            </a:extLst>
          </p:cNvPr>
          <p:cNvSpPr txBox="1"/>
          <p:nvPr/>
        </p:nvSpPr>
        <p:spPr>
          <a:xfrm>
            <a:off x="316460" y="3645161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/>
              <a:t>tiglyl</a:t>
            </a:r>
            <a:r>
              <a:rPr lang="en-US" sz="800" dirty="0"/>
              <a:t> carnitine (C5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07C4470-7427-4855-8634-CE04D555CCFE}"/>
              </a:ext>
            </a:extLst>
          </p:cNvPr>
          <p:cNvSpPr txBox="1"/>
          <p:nvPr/>
        </p:nvSpPr>
        <p:spPr>
          <a:xfrm>
            <a:off x="3831193" y="3645161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/>
              <a:t>isovalerylcarnitine</a:t>
            </a:r>
            <a:r>
              <a:rPr lang="en-US" sz="800" dirty="0"/>
              <a:t> (C5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B242ED-98A1-48B1-B244-3D32A77D09CB}"/>
              </a:ext>
            </a:extLst>
          </p:cNvPr>
          <p:cNvSpPr txBox="1"/>
          <p:nvPr/>
        </p:nvSpPr>
        <p:spPr>
          <a:xfrm>
            <a:off x="316452" y="6478835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/>
              <a:t>hexanoylcarnitine</a:t>
            </a:r>
            <a:r>
              <a:rPr lang="en-US" sz="800" dirty="0"/>
              <a:t> (C6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6AF68FD-A3FA-4332-972A-BA6C650DFA32}"/>
              </a:ext>
            </a:extLst>
          </p:cNvPr>
          <p:cNvSpPr txBox="1"/>
          <p:nvPr/>
        </p:nvSpPr>
        <p:spPr>
          <a:xfrm>
            <a:off x="3831185" y="6478835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/>
              <a:t>octanoylcarnitine</a:t>
            </a:r>
            <a:r>
              <a:rPr lang="en-US" sz="800" dirty="0"/>
              <a:t> (C8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01611A4-9313-48E7-A168-381348369E58}"/>
              </a:ext>
            </a:extLst>
          </p:cNvPr>
          <p:cNvSpPr txBox="1"/>
          <p:nvPr/>
        </p:nvSpPr>
        <p:spPr>
          <a:xfrm rot="16200000">
            <a:off x="-436571" y="1854432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4ED2ED2-C459-4E39-AD50-E1A402164AF9}"/>
              </a:ext>
            </a:extLst>
          </p:cNvPr>
          <p:cNvSpPr txBox="1"/>
          <p:nvPr/>
        </p:nvSpPr>
        <p:spPr>
          <a:xfrm rot="16200000">
            <a:off x="3089711" y="1874368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445445-B5CD-40E4-9126-5DC22BC20058}"/>
              </a:ext>
            </a:extLst>
          </p:cNvPr>
          <p:cNvSpPr txBox="1"/>
          <p:nvPr/>
        </p:nvSpPr>
        <p:spPr>
          <a:xfrm rot="16200000">
            <a:off x="-436577" y="4683388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C8C5EC3-988B-46D2-B293-86A15D02A524}"/>
              </a:ext>
            </a:extLst>
          </p:cNvPr>
          <p:cNvSpPr txBox="1"/>
          <p:nvPr/>
        </p:nvSpPr>
        <p:spPr>
          <a:xfrm rot="16200000">
            <a:off x="-436579" y="7507560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7364912-D1DF-4CC3-8518-7367C25FE080}"/>
              </a:ext>
            </a:extLst>
          </p:cNvPr>
          <p:cNvSpPr txBox="1"/>
          <p:nvPr/>
        </p:nvSpPr>
        <p:spPr>
          <a:xfrm rot="16200000">
            <a:off x="3095835" y="4694277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F8E0BE3-4E80-4BA1-805A-0648833284D6}"/>
              </a:ext>
            </a:extLst>
          </p:cNvPr>
          <p:cNvSpPr txBox="1"/>
          <p:nvPr/>
        </p:nvSpPr>
        <p:spPr>
          <a:xfrm rot="16200000">
            <a:off x="3095833" y="7518449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40" name="Footer Placeholder 1">
            <a:extLst>
              <a:ext uri="{FF2B5EF4-FFF2-40B4-BE49-F238E27FC236}">
                <a16:creationId xmlns:a16="http://schemas.microsoft.com/office/drawing/2014/main" id="{448CF5C4-157B-4B9E-B149-36988608F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676527"/>
            <a:ext cx="2314575" cy="486833"/>
          </a:xfrm>
        </p:spPr>
        <p:txBody>
          <a:bodyPr/>
          <a:lstStyle/>
          <a:p>
            <a:r>
              <a:rPr lang="en-US" dirty="0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4237010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2536666-8A85-4C49-AF2B-3B6689997A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68" y="763551"/>
            <a:ext cx="3017520" cy="271297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92954F2-3152-41E9-82AC-1863BAD635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0696" y="763550"/>
            <a:ext cx="3017520" cy="271297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0DFB18C-D569-40D9-B00C-2802DB1B0F2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10" y="3597287"/>
            <a:ext cx="3017520" cy="271297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75B11A8-6E54-4E3C-AE72-AFB820CC2EF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322" y="3597288"/>
            <a:ext cx="3017520" cy="271297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151D378-10D6-45FA-835A-B4A4FBBC95B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68" y="6431026"/>
            <a:ext cx="3017520" cy="2712973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03A6B4B-65ED-4618-A1D7-D5481A93FBAD}"/>
              </a:ext>
            </a:extLst>
          </p:cNvPr>
          <p:cNvSpPr txBox="1"/>
          <p:nvPr/>
        </p:nvSpPr>
        <p:spPr>
          <a:xfrm>
            <a:off x="0" y="8855528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</a:t>
            </a:r>
            <a:r>
              <a:rPr lang="en-US" sz="600" dirty="0">
                <a:solidFill>
                  <a:schemeClr val="bg1"/>
                </a:solidFill>
              </a:rPr>
              <a:t>          Q1                              Q2                             Q3                             Q4</a:t>
            </a:r>
          </a:p>
          <a:p>
            <a:r>
              <a:rPr lang="en-US" sz="600" dirty="0"/>
              <a:t>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>
                <a:solidFill>
                  <a:schemeClr val="bg1"/>
                </a:solidFill>
              </a:rPr>
              <a:t>N-</a:t>
            </a:r>
            <a:r>
              <a:rPr lang="en-US" sz="800" dirty="0" err="1">
                <a:solidFill>
                  <a:schemeClr val="bg1"/>
                </a:solidFill>
              </a:rPr>
              <a:t>formylmethioninie</a:t>
            </a:r>
            <a:r>
              <a:rPr lang="en-US" sz="800" dirty="0">
                <a:solidFill>
                  <a:schemeClr val="bg1"/>
                </a:solidFill>
              </a:rPr>
              <a:t> Quartile</a:t>
            </a:r>
            <a:endParaRPr lang="en-US" sz="600" dirty="0">
              <a:solidFill>
                <a:schemeClr val="bg1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93C29DA-87D1-47D7-9004-5A66292E2386}"/>
              </a:ext>
            </a:extLst>
          </p:cNvPr>
          <p:cNvSpPr txBox="1"/>
          <p:nvPr/>
        </p:nvSpPr>
        <p:spPr>
          <a:xfrm>
            <a:off x="2" y="6022296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</a:t>
            </a:r>
          </a:p>
          <a:p>
            <a:r>
              <a:rPr lang="en-US" sz="600" dirty="0"/>
              <a:t>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endParaRPr lang="en-US" sz="6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C7372F3-C6FB-40AF-BB64-BAE393B4F855}"/>
              </a:ext>
            </a:extLst>
          </p:cNvPr>
          <p:cNvSpPr txBox="1"/>
          <p:nvPr/>
        </p:nvSpPr>
        <p:spPr>
          <a:xfrm>
            <a:off x="-1" y="3199448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                         </a:t>
            </a:r>
          </a:p>
          <a:p>
            <a:r>
              <a:rPr lang="en-US" sz="600" dirty="0"/>
              <a:t>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543731C-A43A-49A4-9E34-99D5B7D80391}"/>
              </a:ext>
            </a:extLst>
          </p:cNvPr>
          <p:cNvSpPr txBox="1"/>
          <p:nvPr/>
        </p:nvSpPr>
        <p:spPr>
          <a:xfrm>
            <a:off x="188321" y="105846"/>
            <a:ext cx="606484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dditional file 5. (Continued) VITdAL-ICU cohort Day 0 BCAA Metabolism by N-formylmethionine quartiles</a:t>
            </a:r>
            <a:r>
              <a:rPr lang="en-US" sz="1200" b="1" dirty="0"/>
              <a:t>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9EDE0B1-48DB-4F47-92C7-4E1944AD044D}"/>
              </a:ext>
            </a:extLst>
          </p:cNvPr>
          <p:cNvSpPr txBox="1"/>
          <p:nvPr/>
        </p:nvSpPr>
        <p:spPr>
          <a:xfrm>
            <a:off x="311700" y="811460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2-hydroxy-3-methylvalerat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6E9EAEE-30AB-40D3-883B-E810817F0FD2}"/>
              </a:ext>
            </a:extLst>
          </p:cNvPr>
          <p:cNvSpPr txBox="1"/>
          <p:nvPr/>
        </p:nvSpPr>
        <p:spPr>
          <a:xfrm>
            <a:off x="3826433" y="811460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beta-</a:t>
            </a:r>
            <a:r>
              <a:rPr lang="en-US" sz="800" dirty="0" err="1"/>
              <a:t>hydroxyisovalerate</a:t>
            </a:r>
            <a:endParaRPr lang="en-US" sz="800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B5E89BB-146B-4DBB-8599-80E7EA0EEF09}"/>
              </a:ext>
            </a:extLst>
          </p:cNvPr>
          <p:cNvSpPr/>
          <p:nvPr/>
        </p:nvSpPr>
        <p:spPr>
          <a:xfrm>
            <a:off x="0" y="962025"/>
            <a:ext cx="188321" cy="7939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120134E-3B46-4FA6-87CA-9F28BF933C17}"/>
              </a:ext>
            </a:extLst>
          </p:cNvPr>
          <p:cNvSpPr/>
          <p:nvPr/>
        </p:nvSpPr>
        <p:spPr>
          <a:xfrm>
            <a:off x="3552833" y="1052506"/>
            <a:ext cx="188321" cy="7939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058FDA6-AAFF-4D90-85EC-B7A4D310247D}"/>
              </a:ext>
            </a:extLst>
          </p:cNvPr>
          <p:cNvSpPr txBox="1"/>
          <p:nvPr/>
        </p:nvSpPr>
        <p:spPr>
          <a:xfrm>
            <a:off x="316460" y="3645161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3-hydroxy-2-ethylpropionat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07C4470-7427-4855-8634-CE04D555CCFE}"/>
              </a:ext>
            </a:extLst>
          </p:cNvPr>
          <p:cNvSpPr txBox="1"/>
          <p:nvPr/>
        </p:nvSpPr>
        <p:spPr>
          <a:xfrm>
            <a:off x="3831193" y="3645161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alpha-</a:t>
            </a:r>
            <a:r>
              <a:rPr lang="en-US" sz="800" dirty="0" err="1"/>
              <a:t>hydroxyisovalerate</a:t>
            </a:r>
            <a:endParaRPr lang="en-US" sz="8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B242ED-98A1-48B1-B244-3D32A77D09CB}"/>
              </a:ext>
            </a:extLst>
          </p:cNvPr>
          <p:cNvSpPr txBox="1"/>
          <p:nvPr/>
        </p:nvSpPr>
        <p:spPr>
          <a:xfrm>
            <a:off x="316452" y="6478835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2-hydroxy-3-methylvalerat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01611A4-9313-48E7-A168-381348369E58}"/>
              </a:ext>
            </a:extLst>
          </p:cNvPr>
          <p:cNvSpPr txBox="1"/>
          <p:nvPr/>
        </p:nvSpPr>
        <p:spPr>
          <a:xfrm rot="16200000">
            <a:off x="-436571" y="1854432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4ED2ED2-C459-4E39-AD50-E1A402164AF9}"/>
              </a:ext>
            </a:extLst>
          </p:cNvPr>
          <p:cNvSpPr txBox="1"/>
          <p:nvPr/>
        </p:nvSpPr>
        <p:spPr>
          <a:xfrm rot="16200000">
            <a:off x="3121796" y="1874368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445445-B5CD-40E4-9126-5DC22BC20058}"/>
              </a:ext>
            </a:extLst>
          </p:cNvPr>
          <p:cNvSpPr txBox="1"/>
          <p:nvPr/>
        </p:nvSpPr>
        <p:spPr>
          <a:xfrm rot="16200000">
            <a:off x="-436577" y="4683388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C8C5EC3-988B-46D2-B293-86A15D02A524}"/>
              </a:ext>
            </a:extLst>
          </p:cNvPr>
          <p:cNvSpPr txBox="1"/>
          <p:nvPr/>
        </p:nvSpPr>
        <p:spPr>
          <a:xfrm rot="16200000">
            <a:off x="-436579" y="7507560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0AE9C98-9E77-433C-ABA1-70DCEAFF0CF0}"/>
              </a:ext>
            </a:extLst>
          </p:cNvPr>
          <p:cNvSpPr txBox="1"/>
          <p:nvPr/>
        </p:nvSpPr>
        <p:spPr>
          <a:xfrm rot="16200000">
            <a:off x="3095841" y="1865321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7364912-D1DF-4CC3-8518-7367C25FE080}"/>
              </a:ext>
            </a:extLst>
          </p:cNvPr>
          <p:cNvSpPr txBox="1"/>
          <p:nvPr/>
        </p:nvSpPr>
        <p:spPr>
          <a:xfrm rot="16200000">
            <a:off x="3095835" y="4694277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2" name="Footer Placeholder 1">
            <a:extLst>
              <a:ext uri="{FF2B5EF4-FFF2-40B4-BE49-F238E27FC236}">
                <a16:creationId xmlns:a16="http://schemas.microsoft.com/office/drawing/2014/main" id="{73B3EA5C-4168-498C-9067-6398EFD78985}"/>
              </a:ext>
            </a:extLst>
          </p:cNvPr>
          <p:cNvSpPr txBox="1">
            <a:spLocks/>
          </p:cNvSpPr>
          <p:nvPr/>
        </p:nvSpPr>
        <p:spPr>
          <a:xfrm>
            <a:off x="2271713" y="867652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ctr" defTabSz="457200" rtl="0" eaLnBrk="1" latinLnBrk="0" hangingPunct="1">
              <a:defRPr sz="9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29023971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59">
            <a:extLst>
              <a:ext uri="{FF2B5EF4-FFF2-40B4-BE49-F238E27FC236}">
                <a16:creationId xmlns:a16="http://schemas.microsoft.com/office/drawing/2014/main" id="{1BF12A06-C628-46C5-AA99-F701ABCB9B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741" y="3591229"/>
            <a:ext cx="3020635" cy="2715768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20679829-9234-4743-8902-FAD9722336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504" y="755901"/>
            <a:ext cx="3020635" cy="2715768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78D2B477-E2C0-4049-A08D-A9076266EF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64" y="6427833"/>
            <a:ext cx="3020635" cy="2715768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D47BF3BA-6E48-4526-AD00-F5FBDBE3F44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8298" y="755094"/>
            <a:ext cx="3020635" cy="2715768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9AF79CD3-E6C8-4861-A15F-501BDF02254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912" y="3591286"/>
            <a:ext cx="3020635" cy="2715768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25110A07-70FB-4563-92AD-76CC900B384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518" y="6428551"/>
            <a:ext cx="3020635" cy="271576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03A6B4B-65ED-4618-A1D7-D5481A93FBAD}"/>
              </a:ext>
            </a:extLst>
          </p:cNvPr>
          <p:cNvSpPr txBox="1"/>
          <p:nvPr/>
        </p:nvSpPr>
        <p:spPr>
          <a:xfrm>
            <a:off x="0" y="8855528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</a:t>
            </a:r>
          </a:p>
          <a:p>
            <a:r>
              <a:rPr lang="en-US" sz="600" dirty="0"/>
              <a:t>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endParaRPr lang="en-US" sz="6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93C29DA-87D1-47D7-9004-5A66292E2386}"/>
              </a:ext>
            </a:extLst>
          </p:cNvPr>
          <p:cNvSpPr txBox="1"/>
          <p:nvPr/>
        </p:nvSpPr>
        <p:spPr>
          <a:xfrm>
            <a:off x="2" y="6022296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</a:t>
            </a:r>
          </a:p>
          <a:p>
            <a:r>
              <a:rPr lang="en-US" sz="600" dirty="0"/>
              <a:t>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endParaRPr lang="en-US" sz="6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C7372F3-C6FB-40AF-BB64-BAE393B4F855}"/>
              </a:ext>
            </a:extLst>
          </p:cNvPr>
          <p:cNvSpPr txBox="1"/>
          <p:nvPr/>
        </p:nvSpPr>
        <p:spPr>
          <a:xfrm>
            <a:off x="-1" y="3199448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                         </a:t>
            </a:r>
          </a:p>
          <a:p>
            <a:r>
              <a:rPr lang="en-US" sz="600" dirty="0"/>
              <a:t>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543731C-A43A-49A4-9E34-99D5B7D80391}"/>
              </a:ext>
            </a:extLst>
          </p:cNvPr>
          <p:cNvSpPr txBox="1"/>
          <p:nvPr/>
        </p:nvSpPr>
        <p:spPr>
          <a:xfrm>
            <a:off x="188321" y="105846"/>
            <a:ext cx="606484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dditional file 5. (Continued) VITdAL-ICU cohort Day 0 Pentose Phosphate Pathway Metabolism by N-formylmethionine quartiles</a:t>
            </a:r>
            <a:r>
              <a:rPr lang="en-US" sz="1200" b="1" dirty="0"/>
              <a:t>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9EDE0B1-48DB-4F47-92C7-4E1944AD044D}"/>
              </a:ext>
            </a:extLst>
          </p:cNvPr>
          <p:cNvSpPr txBox="1"/>
          <p:nvPr/>
        </p:nvSpPr>
        <p:spPr>
          <a:xfrm>
            <a:off x="311700" y="811460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/>
              <a:t>arabonate</a:t>
            </a:r>
            <a:r>
              <a:rPr lang="en-US" sz="800" dirty="0"/>
              <a:t>/</a:t>
            </a:r>
            <a:r>
              <a:rPr lang="en-US" sz="800" dirty="0" err="1"/>
              <a:t>xylonate</a:t>
            </a:r>
            <a:endParaRPr lang="en-US" sz="8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6E9EAEE-30AB-40D3-883B-E810817F0FD2}"/>
              </a:ext>
            </a:extLst>
          </p:cNvPr>
          <p:cNvSpPr txBox="1"/>
          <p:nvPr/>
        </p:nvSpPr>
        <p:spPr>
          <a:xfrm>
            <a:off x="3826433" y="811460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/>
              <a:t>arabitol</a:t>
            </a:r>
            <a:endParaRPr lang="en-US" sz="800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B5E89BB-146B-4DBB-8599-80E7EA0EEF09}"/>
              </a:ext>
            </a:extLst>
          </p:cNvPr>
          <p:cNvSpPr/>
          <p:nvPr/>
        </p:nvSpPr>
        <p:spPr>
          <a:xfrm>
            <a:off x="0" y="962025"/>
            <a:ext cx="188321" cy="7939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120134E-3B46-4FA6-87CA-9F28BF933C17}"/>
              </a:ext>
            </a:extLst>
          </p:cNvPr>
          <p:cNvSpPr/>
          <p:nvPr/>
        </p:nvSpPr>
        <p:spPr>
          <a:xfrm>
            <a:off x="3552833" y="1052506"/>
            <a:ext cx="188321" cy="7939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058FDA6-AAFF-4D90-85EC-B7A4D310247D}"/>
              </a:ext>
            </a:extLst>
          </p:cNvPr>
          <p:cNvSpPr txBox="1"/>
          <p:nvPr/>
        </p:nvSpPr>
        <p:spPr>
          <a:xfrm>
            <a:off x="316460" y="3645161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arabinos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07C4470-7427-4855-8634-CE04D555CCFE}"/>
              </a:ext>
            </a:extLst>
          </p:cNvPr>
          <p:cNvSpPr txBox="1"/>
          <p:nvPr/>
        </p:nvSpPr>
        <p:spPr>
          <a:xfrm>
            <a:off x="3831193" y="3645161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/>
              <a:t>ribitol</a:t>
            </a:r>
            <a:endParaRPr lang="en-US" sz="8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B242ED-98A1-48B1-B244-3D32A77D09CB}"/>
              </a:ext>
            </a:extLst>
          </p:cNvPr>
          <p:cNvSpPr txBox="1"/>
          <p:nvPr/>
        </p:nvSpPr>
        <p:spPr>
          <a:xfrm>
            <a:off x="316452" y="6478835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 err="1"/>
              <a:t>erythronate</a:t>
            </a:r>
            <a:endParaRPr lang="en-US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6AF68FD-A3FA-4332-972A-BA6C650DFA32}"/>
              </a:ext>
            </a:extLst>
          </p:cNvPr>
          <p:cNvSpPr txBox="1"/>
          <p:nvPr/>
        </p:nvSpPr>
        <p:spPr>
          <a:xfrm>
            <a:off x="3831185" y="6478835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erythrito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01611A4-9313-48E7-A168-381348369E58}"/>
              </a:ext>
            </a:extLst>
          </p:cNvPr>
          <p:cNvSpPr txBox="1"/>
          <p:nvPr/>
        </p:nvSpPr>
        <p:spPr>
          <a:xfrm rot="16200000">
            <a:off x="-436571" y="1854432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4ED2ED2-C459-4E39-AD50-E1A402164AF9}"/>
              </a:ext>
            </a:extLst>
          </p:cNvPr>
          <p:cNvSpPr txBox="1"/>
          <p:nvPr/>
        </p:nvSpPr>
        <p:spPr>
          <a:xfrm rot="16200000">
            <a:off x="3121796" y="1874368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445445-B5CD-40E4-9126-5DC22BC20058}"/>
              </a:ext>
            </a:extLst>
          </p:cNvPr>
          <p:cNvSpPr txBox="1"/>
          <p:nvPr/>
        </p:nvSpPr>
        <p:spPr>
          <a:xfrm rot="16200000">
            <a:off x="-436577" y="4683388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C8C5EC3-988B-46D2-B293-86A15D02A524}"/>
              </a:ext>
            </a:extLst>
          </p:cNvPr>
          <p:cNvSpPr txBox="1"/>
          <p:nvPr/>
        </p:nvSpPr>
        <p:spPr>
          <a:xfrm rot="16200000">
            <a:off x="-436579" y="7507560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0AE9C98-9E77-433C-ABA1-70DCEAFF0CF0}"/>
              </a:ext>
            </a:extLst>
          </p:cNvPr>
          <p:cNvSpPr txBox="1"/>
          <p:nvPr/>
        </p:nvSpPr>
        <p:spPr>
          <a:xfrm rot="16200000">
            <a:off x="3095841" y="1865321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7364912-D1DF-4CC3-8518-7367C25FE080}"/>
              </a:ext>
            </a:extLst>
          </p:cNvPr>
          <p:cNvSpPr txBox="1"/>
          <p:nvPr/>
        </p:nvSpPr>
        <p:spPr>
          <a:xfrm rot="16200000">
            <a:off x="3095835" y="4694277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F8E0BE3-4E80-4BA1-805A-0648833284D6}"/>
              </a:ext>
            </a:extLst>
          </p:cNvPr>
          <p:cNvSpPr txBox="1"/>
          <p:nvPr/>
        </p:nvSpPr>
        <p:spPr>
          <a:xfrm rot="16200000">
            <a:off x="3095833" y="7518449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1F2C60AA-5395-42C2-B2FD-34FBBFEB7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8676527"/>
            <a:ext cx="2314575" cy="486833"/>
          </a:xfrm>
        </p:spPr>
        <p:txBody>
          <a:bodyPr/>
          <a:lstStyle/>
          <a:p>
            <a:r>
              <a:rPr lang="en-US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17175118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B17DED5-D310-4393-A500-2124985D3E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92" y="6429863"/>
            <a:ext cx="3020635" cy="271576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E65FCB7-C48F-405F-B551-8FB634E1A62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9483" y="3591932"/>
            <a:ext cx="3020635" cy="271576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8797987-AF6B-4A97-94B1-33CD81CACF0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92" y="3591932"/>
            <a:ext cx="3020635" cy="271576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C7F2117-2B99-4E17-8583-8F0AF68596E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93" y="755156"/>
            <a:ext cx="3020635" cy="271576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1E2088B-A23E-4CD4-B3C5-3136A61E718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4774" y="755626"/>
            <a:ext cx="3020635" cy="271576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03A6B4B-65ED-4618-A1D7-D5481A93FBAD}"/>
              </a:ext>
            </a:extLst>
          </p:cNvPr>
          <p:cNvSpPr txBox="1"/>
          <p:nvPr/>
        </p:nvSpPr>
        <p:spPr>
          <a:xfrm>
            <a:off x="0" y="8855528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</a:t>
            </a:r>
            <a:r>
              <a:rPr lang="en-US" sz="600" b="1" dirty="0"/>
              <a:t>    </a:t>
            </a:r>
            <a:r>
              <a:rPr lang="en-US" sz="600" dirty="0"/>
              <a:t>                                              </a:t>
            </a:r>
            <a:r>
              <a:rPr lang="en-US" sz="600" dirty="0">
                <a:solidFill>
                  <a:schemeClr val="bg1"/>
                </a:solidFill>
              </a:rPr>
              <a:t>Q1                              Q2                             Q3                             Q4</a:t>
            </a:r>
          </a:p>
          <a:p>
            <a:r>
              <a:rPr lang="en-US" sz="600" dirty="0"/>
              <a:t>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>
                <a:solidFill>
                  <a:schemeClr val="bg1"/>
                </a:solidFill>
              </a:rPr>
              <a:t>N-</a:t>
            </a:r>
            <a:r>
              <a:rPr lang="en-US" sz="800" dirty="0" err="1">
                <a:solidFill>
                  <a:schemeClr val="bg1"/>
                </a:solidFill>
              </a:rPr>
              <a:t>formylmethioninie</a:t>
            </a:r>
            <a:r>
              <a:rPr lang="en-US" sz="800" dirty="0">
                <a:solidFill>
                  <a:schemeClr val="bg1"/>
                </a:solidFill>
              </a:rPr>
              <a:t> Quartile</a:t>
            </a:r>
            <a:endParaRPr lang="en-US" sz="600" dirty="0">
              <a:solidFill>
                <a:schemeClr val="bg1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93C29DA-87D1-47D7-9004-5A66292E2386}"/>
              </a:ext>
            </a:extLst>
          </p:cNvPr>
          <p:cNvSpPr txBox="1"/>
          <p:nvPr/>
        </p:nvSpPr>
        <p:spPr>
          <a:xfrm>
            <a:off x="2" y="6022296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</a:t>
            </a:r>
          </a:p>
          <a:p>
            <a:r>
              <a:rPr lang="en-US" sz="600" dirty="0"/>
              <a:t>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endParaRPr lang="en-US" sz="6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C7372F3-C6FB-40AF-BB64-BAE393B4F855}"/>
              </a:ext>
            </a:extLst>
          </p:cNvPr>
          <p:cNvSpPr txBox="1"/>
          <p:nvPr/>
        </p:nvSpPr>
        <p:spPr>
          <a:xfrm>
            <a:off x="-1" y="3199448"/>
            <a:ext cx="68580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600" dirty="0"/>
              <a:t>                                   Q1                              Q2                             Q3                              Q4                                                                                               Q1                              Q2                             Q3                             Q4                         </a:t>
            </a:r>
          </a:p>
          <a:p>
            <a:r>
              <a:rPr lang="en-US" sz="600" dirty="0"/>
              <a:t>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  <a:r>
              <a:rPr lang="en-US" sz="600" dirty="0"/>
              <a:t>                                                                                                                                     </a:t>
            </a:r>
            <a:r>
              <a:rPr lang="en-US" sz="800" dirty="0"/>
              <a:t>N-</a:t>
            </a:r>
            <a:r>
              <a:rPr lang="en-US" sz="800" dirty="0" err="1"/>
              <a:t>formylmethioninie</a:t>
            </a:r>
            <a:r>
              <a:rPr lang="en-US" sz="800" dirty="0"/>
              <a:t> Quartil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543731C-A43A-49A4-9E34-99D5B7D80391}"/>
              </a:ext>
            </a:extLst>
          </p:cNvPr>
          <p:cNvSpPr txBox="1"/>
          <p:nvPr/>
        </p:nvSpPr>
        <p:spPr>
          <a:xfrm>
            <a:off x="188321" y="105846"/>
            <a:ext cx="606484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dditional file 5. (Continued) VITdAL-ICU cohort Day 0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</a:rPr>
              <a:t>Purine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Metabolism by N-formylmethionine quartiles</a:t>
            </a:r>
            <a:r>
              <a:rPr lang="en-US" sz="1200" b="1" dirty="0"/>
              <a:t>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9EDE0B1-48DB-4F47-92C7-4E1944AD044D}"/>
              </a:ext>
            </a:extLst>
          </p:cNvPr>
          <p:cNvSpPr txBox="1"/>
          <p:nvPr/>
        </p:nvSpPr>
        <p:spPr>
          <a:xfrm>
            <a:off x="311700" y="788014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allanto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6E9EAEE-30AB-40D3-883B-E810817F0FD2}"/>
              </a:ext>
            </a:extLst>
          </p:cNvPr>
          <p:cNvSpPr txBox="1"/>
          <p:nvPr/>
        </p:nvSpPr>
        <p:spPr>
          <a:xfrm>
            <a:off x="3826433" y="788014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N6-carbamoylthreonyladenosine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B5E89BB-146B-4DBB-8599-80E7EA0EEF09}"/>
              </a:ext>
            </a:extLst>
          </p:cNvPr>
          <p:cNvSpPr/>
          <p:nvPr/>
        </p:nvSpPr>
        <p:spPr>
          <a:xfrm>
            <a:off x="0" y="962025"/>
            <a:ext cx="188321" cy="7939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120134E-3B46-4FA6-87CA-9F28BF933C17}"/>
              </a:ext>
            </a:extLst>
          </p:cNvPr>
          <p:cNvSpPr/>
          <p:nvPr/>
        </p:nvSpPr>
        <p:spPr>
          <a:xfrm>
            <a:off x="3552833" y="1052506"/>
            <a:ext cx="188321" cy="79390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058FDA6-AAFF-4D90-85EC-B7A4D310247D}"/>
              </a:ext>
            </a:extLst>
          </p:cNvPr>
          <p:cNvSpPr txBox="1"/>
          <p:nvPr/>
        </p:nvSpPr>
        <p:spPr>
          <a:xfrm>
            <a:off x="316460" y="3645161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1-methyladenosin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07C4470-7427-4855-8634-CE04D555CCFE}"/>
              </a:ext>
            </a:extLst>
          </p:cNvPr>
          <p:cNvSpPr txBox="1"/>
          <p:nvPr/>
        </p:nvSpPr>
        <p:spPr>
          <a:xfrm>
            <a:off x="3831193" y="3645161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N2,N2-dimethylguanosin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B242ED-98A1-48B1-B244-3D32A77D09CB}"/>
              </a:ext>
            </a:extLst>
          </p:cNvPr>
          <p:cNvSpPr txBox="1"/>
          <p:nvPr/>
        </p:nvSpPr>
        <p:spPr>
          <a:xfrm>
            <a:off x="316452" y="6478835"/>
            <a:ext cx="18383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7-methylguanin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01611A4-9313-48E7-A168-381348369E58}"/>
              </a:ext>
            </a:extLst>
          </p:cNvPr>
          <p:cNvSpPr txBox="1"/>
          <p:nvPr/>
        </p:nvSpPr>
        <p:spPr>
          <a:xfrm rot="16200000">
            <a:off x="-436571" y="1854432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445445-B5CD-40E4-9126-5DC22BC20058}"/>
              </a:ext>
            </a:extLst>
          </p:cNvPr>
          <p:cNvSpPr txBox="1"/>
          <p:nvPr/>
        </p:nvSpPr>
        <p:spPr>
          <a:xfrm rot="16200000">
            <a:off x="-436577" y="4683388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C8C5EC3-988B-46D2-B293-86A15D02A524}"/>
              </a:ext>
            </a:extLst>
          </p:cNvPr>
          <p:cNvSpPr txBox="1"/>
          <p:nvPr/>
        </p:nvSpPr>
        <p:spPr>
          <a:xfrm rot="16200000">
            <a:off x="-436579" y="7507560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0AE9C98-9E77-433C-ABA1-70DCEAFF0CF0}"/>
              </a:ext>
            </a:extLst>
          </p:cNvPr>
          <p:cNvSpPr txBox="1"/>
          <p:nvPr/>
        </p:nvSpPr>
        <p:spPr>
          <a:xfrm rot="16200000">
            <a:off x="3098663" y="1865321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7364912-D1DF-4CC3-8518-7367C25FE080}"/>
              </a:ext>
            </a:extLst>
          </p:cNvPr>
          <p:cNvSpPr txBox="1"/>
          <p:nvPr/>
        </p:nvSpPr>
        <p:spPr>
          <a:xfrm rot="16200000">
            <a:off x="3095835" y="4694277"/>
            <a:ext cx="10953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Relative Abundance</a:t>
            </a:r>
          </a:p>
        </p:txBody>
      </p:sp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E26B75F9-3803-4BFD-8FA4-5207B88B6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1" y="8667635"/>
            <a:ext cx="2314575" cy="486833"/>
          </a:xfrm>
        </p:spPr>
        <p:txBody>
          <a:bodyPr/>
          <a:lstStyle/>
          <a:p>
            <a:fld id="{3EF2E9F6-D5D7-4E89-A2ED-E99393BCDF03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32540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68</TotalTime>
  <Words>329</Words>
  <Application>Microsoft Office PowerPoint</Application>
  <PresentationFormat>On-screen Show (4:3)</PresentationFormat>
  <Paragraphs>7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neth christopher</dc:creator>
  <cp:lastModifiedBy>kenneth christopher</cp:lastModifiedBy>
  <cp:revision>23</cp:revision>
  <dcterms:created xsi:type="dcterms:W3CDTF">2021-03-06T19:06:02Z</dcterms:created>
  <dcterms:modified xsi:type="dcterms:W3CDTF">2022-09-02T17:36:25Z</dcterms:modified>
</cp:coreProperties>
</file>